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382" r:id="rId2"/>
    <p:sldId id="383" r:id="rId3"/>
  </p:sldIdLst>
  <p:sldSz cx="7772400" cy="10058400"/>
  <p:notesSz cx="6802438" cy="9934575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70"/>
    <a:srgbClr val="00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169" autoAdjust="0"/>
    <p:restoredTop sz="96144" autoAdjust="0"/>
  </p:normalViewPr>
  <p:slideViewPr>
    <p:cSldViewPr snapToGrid="0">
      <p:cViewPr varScale="1">
        <p:scale>
          <a:sx n="65" d="100"/>
          <a:sy n="65" d="100"/>
        </p:scale>
        <p:origin x="94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7988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2863" y="0"/>
            <a:ext cx="2947987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AC72701-E2FA-483A-B720-0AF19BC2A5E9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06613" y="1241425"/>
            <a:ext cx="2590800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1038" y="4781550"/>
            <a:ext cx="5441950" cy="39116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36100"/>
            <a:ext cx="2947988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2863" y="9436100"/>
            <a:ext cx="2947987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7BEBD1-C84B-4EE5-84D2-C6D38436860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369543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A7BEBD1-C84B-4EE5-84D2-C6D384368605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57327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ko-KR" altLang="en-US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5473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3993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110686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467555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71409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20287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39947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120077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87123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11920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44563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9380E2-BF72-46C4-8963-0BD50AFD31B2}" type="datetimeFigureOut">
              <a:rPr lang="ko-KR" altLang="en-US" smtClean="0"/>
              <a:t>2022-11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996863-4B0E-40F1-86C3-027F888B65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766585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1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1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1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1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18" Type="http://schemas.openxmlformats.org/officeDocument/2006/relationships/image" Target="../media/image16.jpeg"/><Relationship Id="rId3" Type="http://schemas.openxmlformats.org/officeDocument/2006/relationships/image" Target="../media/image1.jpeg"/><Relationship Id="rId21" Type="http://schemas.openxmlformats.org/officeDocument/2006/relationships/image" Target="../media/image19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17" Type="http://schemas.openxmlformats.org/officeDocument/2006/relationships/image" Target="../media/image15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jpeg"/><Relationship Id="rId20" Type="http://schemas.openxmlformats.org/officeDocument/2006/relationships/image" Target="../media/image18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5" Type="http://schemas.openxmlformats.org/officeDocument/2006/relationships/image" Target="../media/image13.jpeg"/><Relationship Id="rId10" Type="http://schemas.openxmlformats.org/officeDocument/2006/relationships/image" Target="../media/image8.jpeg"/><Relationship Id="rId19" Type="http://schemas.openxmlformats.org/officeDocument/2006/relationships/image" Target="../media/image17.jpeg"/><Relationship Id="rId4" Type="http://schemas.openxmlformats.org/officeDocument/2006/relationships/image" Target="../media/image2.jpeg"/><Relationship Id="rId9" Type="http://schemas.openxmlformats.org/officeDocument/2006/relationships/image" Target="../media/image7.png"/><Relationship Id="rId14" Type="http://schemas.openxmlformats.org/officeDocument/2006/relationships/image" Target="../media/image12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7" name="그룹 76"/>
          <p:cNvGrpSpPr/>
          <p:nvPr/>
        </p:nvGrpSpPr>
        <p:grpSpPr>
          <a:xfrm>
            <a:off x="547635" y="8567305"/>
            <a:ext cx="1269197" cy="1356475"/>
            <a:chOff x="547635" y="8567305"/>
            <a:chExt cx="1269197" cy="1356475"/>
          </a:xfrm>
        </p:grpSpPr>
        <p:pic>
          <p:nvPicPr>
            <p:cNvPr id="75" name="그림 7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701" t="21303" r="43382" b="35920"/>
            <a:stretch/>
          </p:blipFill>
          <p:spPr>
            <a:xfrm>
              <a:off x="547635" y="8567305"/>
              <a:ext cx="1269197" cy="135601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76" name="그림 75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703" t="21307" r="69120" b="35905"/>
            <a:stretch/>
          </p:blipFill>
          <p:spPr>
            <a:xfrm>
              <a:off x="547635" y="8567419"/>
              <a:ext cx="177250" cy="1356361"/>
            </a:xfrm>
            <a:prstGeom prst="rect">
              <a:avLst/>
            </a:prstGeom>
          </p:spPr>
        </p:pic>
      </p:grpSp>
      <p:grpSp>
        <p:nvGrpSpPr>
          <p:cNvPr id="78" name="그룹 77"/>
          <p:cNvGrpSpPr/>
          <p:nvPr/>
        </p:nvGrpSpPr>
        <p:grpSpPr>
          <a:xfrm>
            <a:off x="3461911" y="8572254"/>
            <a:ext cx="1266848" cy="1348510"/>
            <a:chOff x="3461911" y="8572254"/>
            <a:chExt cx="1266848" cy="1348510"/>
          </a:xfrm>
        </p:grpSpPr>
        <p:pic>
          <p:nvPicPr>
            <p:cNvPr id="64" name="그림 63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019" t="6342" r="43123" b="51117"/>
            <a:stretch/>
          </p:blipFill>
          <p:spPr>
            <a:xfrm>
              <a:off x="3461911" y="8572254"/>
              <a:ext cx="1266848" cy="134851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65" name="그림 64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016" t="6349" r="68706" b="51182"/>
            <a:stretch/>
          </p:blipFill>
          <p:spPr>
            <a:xfrm>
              <a:off x="3461911" y="8572501"/>
              <a:ext cx="181476" cy="1346200"/>
            </a:xfrm>
            <a:prstGeom prst="rect">
              <a:avLst/>
            </a:prstGeom>
          </p:spPr>
        </p:pic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97B25118-8CB2-4695-82F4-93EAA418417D}"/>
              </a:ext>
            </a:extLst>
          </p:cNvPr>
          <p:cNvSpPr txBox="1"/>
          <p:nvPr/>
        </p:nvSpPr>
        <p:spPr>
          <a:xfrm>
            <a:off x="-40847" y="4363690"/>
            <a:ext cx="4252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88">
            <a:extLst>
              <a:ext uri="{FF2B5EF4-FFF2-40B4-BE49-F238E27FC236}">
                <a16:creationId xmlns:a16="http://schemas.microsoft.com/office/drawing/2014/main" id="{90462EB7-6B63-413F-A479-30935F1656AA}"/>
              </a:ext>
            </a:extLst>
          </p:cNvPr>
          <p:cNvSpPr txBox="1"/>
          <p:nvPr/>
        </p:nvSpPr>
        <p:spPr>
          <a:xfrm>
            <a:off x="213693" y="1248622"/>
            <a:ext cx="4187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88">
            <a:extLst>
              <a:ext uri="{FF2B5EF4-FFF2-40B4-BE49-F238E27FC236}">
                <a16:creationId xmlns:a16="http://schemas.microsoft.com/office/drawing/2014/main" id="{1AB74F98-B7BE-4AF0-8847-8532B81D1531}"/>
              </a:ext>
            </a:extLst>
          </p:cNvPr>
          <p:cNvSpPr txBox="1"/>
          <p:nvPr/>
        </p:nvSpPr>
        <p:spPr>
          <a:xfrm>
            <a:off x="1741256" y="2103415"/>
            <a:ext cx="10334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 : CD4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268164" y="2097729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직선 연결선 10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516045" y="2227211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278515" y="2347069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직선 연결선 13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516045" y="2470839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5" name="그룹 14"/>
          <p:cNvGrpSpPr/>
          <p:nvPr/>
        </p:nvGrpSpPr>
        <p:grpSpPr>
          <a:xfrm>
            <a:off x="553026" y="1446680"/>
            <a:ext cx="1220536" cy="1573259"/>
            <a:chOff x="3131128" y="3863879"/>
            <a:chExt cx="1220536" cy="1573259"/>
          </a:xfrm>
        </p:grpSpPr>
        <p:pic>
          <p:nvPicPr>
            <p:cNvPr id="16" name="그림 15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204" t="13264" r="39029" b="37180"/>
            <a:stretch/>
          </p:blipFill>
          <p:spPr>
            <a:xfrm>
              <a:off x="3131128" y="3864709"/>
              <a:ext cx="1220536" cy="157089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7" name="그림 16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204" t="13238" r="63628" b="37131"/>
            <a:stretch/>
          </p:blipFill>
          <p:spPr>
            <a:xfrm>
              <a:off x="3131128" y="3863879"/>
              <a:ext cx="176848" cy="1573259"/>
            </a:xfrm>
            <a:prstGeom prst="rect">
              <a:avLst/>
            </a:prstGeom>
          </p:spPr>
        </p:pic>
      </p:grpSp>
      <p:sp>
        <p:nvSpPr>
          <p:cNvPr id="19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268164" y="1817896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516045" y="1946603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1" name="그룹 20"/>
          <p:cNvGrpSpPr/>
          <p:nvPr/>
        </p:nvGrpSpPr>
        <p:grpSpPr>
          <a:xfrm>
            <a:off x="3424637" y="1425806"/>
            <a:ext cx="1221671" cy="1574553"/>
            <a:chOff x="3019027" y="3738642"/>
            <a:chExt cx="1221671" cy="1574553"/>
          </a:xfrm>
        </p:grpSpPr>
        <p:pic>
          <p:nvPicPr>
            <p:cNvPr id="22" name="그림 21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580" t="9148" r="41626" b="41181"/>
            <a:stretch/>
          </p:blipFill>
          <p:spPr>
            <a:xfrm>
              <a:off x="3019027" y="3738642"/>
              <a:ext cx="1221671" cy="157455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3" name="그림 22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618" t="9290" r="65934" b="41129"/>
            <a:stretch/>
          </p:blipFill>
          <p:spPr>
            <a:xfrm>
              <a:off x="3021436" y="3738729"/>
              <a:ext cx="188691" cy="1571626"/>
            </a:xfrm>
            <a:prstGeom prst="rect">
              <a:avLst/>
            </a:prstGeom>
          </p:spPr>
        </p:pic>
      </p:grpSp>
      <p:sp>
        <p:nvSpPr>
          <p:cNvPr id="24" name="TextBox 88">
            <a:extLst>
              <a:ext uri="{FF2B5EF4-FFF2-40B4-BE49-F238E27FC236}">
                <a16:creationId xmlns:a16="http://schemas.microsoft.com/office/drawing/2014/main" id="{90462EB7-6B63-413F-A479-30935F1656AA}"/>
              </a:ext>
            </a:extLst>
          </p:cNvPr>
          <p:cNvSpPr txBox="1"/>
          <p:nvPr/>
        </p:nvSpPr>
        <p:spPr>
          <a:xfrm>
            <a:off x="3070286" y="1248622"/>
            <a:ext cx="4419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3139775" y="2084210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직선 연결선 26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3385035" y="2207321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3139775" y="2327817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직선 연결선 29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3385035" y="2450949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3139775" y="1801976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직선 연결선 32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3385035" y="1931046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88">
            <a:extLst>
              <a:ext uri="{FF2B5EF4-FFF2-40B4-BE49-F238E27FC236}">
                <a16:creationId xmlns:a16="http://schemas.microsoft.com/office/drawing/2014/main" id="{1AB74F98-B7BE-4AF0-8847-8532B81D1531}"/>
              </a:ext>
            </a:extLst>
          </p:cNvPr>
          <p:cNvSpPr txBox="1"/>
          <p:nvPr/>
        </p:nvSpPr>
        <p:spPr>
          <a:xfrm>
            <a:off x="4646308" y="2103415"/>
            <a:ext cx="10334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 : CD48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그림 34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92" t="10463" r="41189" b="42025"/>
          <a:stretch/>
        </p:blipFill>
        <p:spPr>
          <a:xfrm>
            <a:off x="552454" y="5414970"/>
            <a:ext cx="1269402" cy="150607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36" name="TextBox 88">
            <a:extLst>
              <a:ext uri="{FF2B5EF4-FFF2-40B4-BE49-F238E27FC236}">
                <a16:creationId xmlns:a16="http://schemas.microsoft.com/office/drawing/2014/main" id="{90462EB7-6B63-413F-A479-30935F1656AA}"/>
              </a:ext>
            </a:extLst>
          </p:cNvPr>
          <p:cNvSpPr txBox="1"/>
          <p:nvPr/>
        </p:nvSpPr>
        <p:spPr>
          <a:xfrm>
            <a:off x="213693" y="5232835"/>
            <a:ext cx="4173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266354" y="5967831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직선 연결선 38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510376" y="6095667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266354" y="6249302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직선 연결선 41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510376" y="6375056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266354" y="5702065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직선 연결선 44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510376" y="5825969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6" name="그룹 45"/>
          <p:cNvGrpSpPr/>
          <p:nvPr/>
        </p:nvGrpSpPr>
        <p:grpSpPr>
          <a:xfrm>
            <a:off x="3463255" y="5414969"/>
            <a:ext cx="1265504" cy="1509668"/>
            <a:chOff x="2059645" y="6464914"/>
            <a:chExt cx="1265504" cy="1509668"/>
          </a:xfrm>
        </p:grpSpPr>
        <p:pic>
          <p:nvPicPr>
            <p:cNvPr id="47" name="그림 46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002" t="17778" r="38192" b="34611"/>
            <a:stretch/>
          </p:blipFill>
          <p:spPr>
            <a:xfrm>
              <a:off x="2060553" y="6464914"/>
              <a:ext cx="1264596" cy="1509205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8" name="그림 47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982" t="17811" r="63563" b="34597"/>
            <a:stretch/>
          </p:blipFill>
          <p:spPr>
            <a:xfrm>
              <a:off x="2059645" y="6465957"/>
              <a:ext cx="189088" cy="1508625"/>
            </a:xfrm>
            <a:prstGeom prst="rect">
              <a:avLst/>
            </a:prstGeom>
          </p:spPr>
        </p:pic>
      </p:grpSp>
      <p:sp>
        <p:nvSpPr>
          <p:cNvPr id="49" name="TextBox 88">
            <a:extLst>
              <a:ext uri="{FF2B5EF4-FFF2-40B4-BE49-F238E27FC236}">
                <a16:creationId xmlns:a16="http://schemas.microsoft.com/office/drawing/2014/main" id="{90462EB7-6B63-413F-A479-30935F1656AA}"/>
              </a:ext>
            </a:extLst>
          </p:cNvPr>
          <p:cNvSpPr txBox="1"/>
          <p:nvPr/>
        </p:nvSpPr>
        <p:spPr>
          <a:xfrm>
            <a:off x="3118490" y="5232835"/>
            <a:ext cx="4183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88">
            <a:extLst>
              <a:ext uri="{FF2B5EF4-FFF2-40B4-BE49-F238E27FC236}">
                <a16:creationId xmlns:a16="http://schemas.microsoft.com/office/drawing/2014/main" id="{F9D0CD2A-4968-4EDA-96D6-84F094984028}"/>
              </a:ext>
            </a:extLst>
          </p:cNvPr>
          <p:cNvSpPr txBox="1"/>
          <p:nvPr/>
        </p:nvSpPr>
        <p:spPr>
          <a:xfrm>
            <a:off x="1799719" y="6101917"/>
            <a:ext cx="9562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: 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pIĸB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      (ser32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88">
            <a:extLst>
              <a:ext uri="{FF2B5EF4-FFF2-40B4-BE49-F238E27FC236}">
                <a16:creationId xmlns:a16="http://schemas.microsoft.com/office/drawing/2014/main" id="{E535DB71-732C-4EF1-ADB9-A823893C7AA3}"/>
              </a:ext>
            </a:extLst>
          </p:cNvPr>
          <p:cNvSpPr txBox="1"/>
          <p:nvPr/>
        </p:nvSpPr>
        <p:spPr>
          <a:xfrm>
            <a:off x="4712602" y="6101917"/>
            <a:ext cx="9562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: 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pNF-ĸB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      (ser536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88">
            <a:extLst>
              <a:ext uri="{FF2B5EF4-FFF2-40B4-BE49-F238E27FC236}">
                <a16:creationId xmlns:a16="http://schemas.microsoft.com/office/drawing/2014/main" id="{1AB74F98-B7BE-4AF0-8847-8532B81D1531}"/>
              </a:ext>
            </a:extLst>
          </p:cNvPr>
          <p:cNvSpPr txBox="1"/>
          <p:nvPr/>
        </p:nvSpPr>
        <p:spPr>
          <a:xfrm>
            <a:off x="1741256" y="3320514"/>
            <a:ext cx="12775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 : 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88">
            <a:extLst>
              <a:ext uri="{FF2B5EF4-FFF2-40B4-BE49-F238E27FC236}">
                <a16:creationId xmlns:a16="http://schemas.microsoft.com/office/drawing/2014/main" id="{02DA3E7C-5C85-480F-9C1E-9C56133CE43C}"/>
              </a:ext>
            </a:extLst>
          </p:cNvPr>
          <p:cNvSpPr txBox="1"/>
          <p:nvPr/>
        </p:nvSpPr>
        <p:spPr>
          <a:xfrm>
            <a:off x="4712602" y="7694394"/>
            <a:ext cx="9562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: NF-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ĸB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88">
            <a:extLst>
              <a:ext uri="{FF2B5EF4-FFF2-40B4-BE49-F238E27FC236}">
                <a16:creationId xmlns:a16="http://schemas.microsoft.com/office/drawing/2014/main" id="{A8B9035E-76E7-407E-B1D2-B33554620D0C}"/>
              </a:ext>
            </a:extLst>
          </p:cNvPr>
          <p:cNvSpPr txBox="1"/>
          <p:nvPr/>
        </p:nvSpPr>
        <p:spPr>
          <a:xfrm>
            <a:off x="1802037" y="7694394"/>
            <a:ext cx="9562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: </a:t>
            </a:r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IĸB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E2BACB09-70E7-464D-BBC7-A40A5DB7BA0D}"/>
              </a:ext>
            </a:extLst>
          </p:cNvPr>
          <p:cNvSpPr txBox="1"/>
          <p:nvPr/>
        </p:nvSpPr>
        <p:spPr>
          <a:xfrm>
            <a:off x="-40036" y="453247"/>
            <a:ext cx="4252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3" name="그룹 202"/>
          <p:cNvGrpSpPr/>
          <p:nvPr/>
        </p:nvGrpSpPr>
        <p:grpSpPr>
          <a:xfrm>
            <a:off x="709403" y="596006"/>
            <a:ext cx="1910840" cy="804011"/>
            <a:chOff x="709403" y="596006"/>
            <a:chExt cx="1910840" cy="804011"/>
          </a:xfrm>
        </p:grpSpPr>
        <p:sp>
          <p:nvSpPr>
            <p:cNvPr id="95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 rot="16200000">
              <a:off x="456081" y="914109"/>
              <a:ext cx="739230" cy="2325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Scramble</a:t>
              </a:r>
            </a:p>
          </p:txBody>
        </p:sp>
        <p:sp>
          <p:nvSpPr>
            <p:cNvPr id="96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684861" y="1147193"/>
              <a:ext cx="9353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-CD40</a:t>
              </a:r>
            </a:p>
          </p:txBody>
        </p:sp>
        <p:sp>
          <p:nvSpPr>
            <p:cNvPr id="97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684861" y="966157"/>
              <a:ext cx="9353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-CD48</a:t>
              </a:r>
            </a:p>
          </p:txBody>
        </p:sp>
        <p:sp>
          <p:nvSpPr>
            <p:cNvPr id="98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684861" y="792431"/>
              <a:ext cx="9353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D40-V5</a:t>
              </a:r>
            </a:p>
          </p:txBody>
        </p:sp>
        <p:sp>
          <p:nvSpPr>
            <p:cNvPr id="99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684861" y="602435"/>
              <a:ext cx="9353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D48-V5</a:t>
              </a:r>
            </a:p>
          </p:txBody>
        </p:sp>
        <p:sp>
          <p:nvSpPr>
            <p:cNvPr id="100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957963" y="1131804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01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197427" y="1131804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02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453096" y="1131804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03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967536" y="951446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04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197427" y="951446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05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450086" y="951446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06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967536" y="770608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07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197427" y="770608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08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439285" y="770608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09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967536" y="596006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10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197427" y="596006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11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436798" y="596006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cxnSp>
          <p:nvCxnSpPr>
            <p:cNvPr id="112" name="직선 연결선 111"/>
            <p:cNvCxnSpPr/>
            <p:nvPr/>
          </p:nvCxnSpPr>
          <p:spPr>
            <a:xfrm>
              <a:off x="724800" y="1387515"/>
              <a:ext cx="21105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직선 연결선 112"/>
            <p:cNvCxnSpPr/>
            <p:nvPr/>
          </p:nvCxnSpPr>
          <p:spPr>
            <a:xfrm>
              <a:off x="991013" y="1387236"/>
              <a:ext cx="719982" cy="27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6" name="TextBox 88">
            <a:extLst>
              <a:ext uri="{FF2B5EF4-FFF2-40B4-BE49-F238E27FC236}">
                <a16:creationId xmlns:a16="http://schemas.microsoft.com/office/drawing/2014/main" id="{1AB74F98-B7BE-4AF0-8847-8532B81D1531}"/>
              </a:ext>
            </a:extLst>
          </p:cNvPr>
          <p:cNvSpPr txBox="1"/>
          <p:nvPr/>
        </p:nvSpPr>
        <p:spPr>
          <a:xfrm>
            <a:off x="4646308" y="3320514"/>
            <a:ext cx="12775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 : 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9F219E5F-E1CB-49C7-B0E3-ECC865CFAE69}"/>
              </a:ext>
            </a:extLst>
          </p:cNvPr>
          <p:cNvSpPr txBox="1"/>
          <p:nvPr/>
        </p:nvSpPr>
        <p:spPr>
          <a:xfrm>
            <a:off x="41652" y="12977"/>
            <a:ext cx="436816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  <a:endParaRPr lang="ko-KR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Box 88">
            <a:extLst>
              <a:ext uri="{FF2B5EF4-FFF2-40B4-BE49-F238E27FC236}">
                <a16:creationId xmlns:a16="http://schemas.microsoft.com/office/drawing/2014/main" id="{1AB74F98-B7BE-4AF0-8847-8532B81D1531}"/>
              </a:ext>
            </a:extLst>
          </p:cNvPr>
          <p:cNvSpPr txBox="1"/>
          <p:nvPr/>
        </p:nvSpPr>
        <p:spPr>
          <a:xfrm>
            <a:off x="1802037" y="9184866"/>
            <a:ext cx="12775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 : 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TextBox 88">
            <a:extLst>
              <a:ext uri="{FF2B5EF4-FFF2-40B4-BE49-F238E27FC236}">
                <a16:creationId xmlns:a16="http://schemas.microsoft.com/office/drawing/2014/main" id="{1AB74F98-B7BE-4AF0-8847-8532B81D1531}"/>
              </a:ext>
            </a:extLst>
          </p:cNvPr>
          <p:cNvSpPr txBox="1"/>
          <p:nvPr/>
        </p:nvSpPr>
        <p:spPr>
          <a:xfrm>
            <a:off x="4712602" y="9184866"/>
            <a:ext cx="12775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B : </a:t>
            </a:r>
            <a:r>
              <a:rPr lang="el-GR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4" name="그룹 203"/>
          <p:cNvGrpSpPr/>
          <p:nvPr/>
        </p:nvGrpSpPr>
        <p:grpSpPr>
          <a:xfrm>
            <a:off x="3615737" y="576301"/>
            <a:ext cx="1910840" cy="804011"/>
            <a:chOff x="709403" y="596006"/>
            <a:chExt cx="1910840" cy="804011"/>
          </a:xfrm>
        </p:grpSpPr>
        <p:sp>
          <p:nvSpPr>
            <p:cNvPr id="205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 rot="16200000">
              <a:off x="456081" y="914109"/>
              <a:ext cx="739230" cy="2325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Scramble</a:t>
              </a:r>
            </a:p>
          </p:txBody>
        </p:sp>
        <p:sp>
          <p:nvSpPr>
            <p:cNvPr id="206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684861" y="1147193"/>
              <a:ext cx="9353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-CD40</a:t>
              </a:r>
            </a:p>
          </p:txBody>
        </p:sp>
        <p:sp>
          <p:nvSpPr>
            <p:cNvPr id="207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684861" y="966157"/>
              <a:ext cx="9353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-CD48</a:t>
              </a:r>
            </a:p>
          </p:txBody>
        </p:sp>
        <p:sp>
          <p:nvSpPr>
            <p:cNvPr id="208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684861" y="792431"/>
              <a:ext cx="9353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D40-V5</a:t>
              </a:r>
            </a:p>
          </p:txBody>
        </p:sp>
        <p:sp>
          <p:nvSpPr>
            <p:cNvPr id="209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684861" y="602435"/>
              <a:ext cx="9353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D48-V5</a:t>
              </a:r>
            </a:p>
          </p:txBody>
        </p:sp>
        <p:sp>
          <p:nvSpPr>
            <p:cNvPr id="210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957963" y="1131804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11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197427" y="1131804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12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453096" y="1131804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13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967536" y="951446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14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197427" y="951446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15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450086" y="951446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16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967536" y="770608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17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197427" y="770608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18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439285" y="770608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19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967536" y="596006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20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197427" y="596006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21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436798" y="596006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cxnSp>
          <p:nvCxnSpPr>
            <p:cNvPr id="222" name="직선 연결선 221"/>
            <p:cNvCxnSpPr/>
            <p:nvPr/>
          </p:nvCxnSpPr>
          <p:spPr>
            <a:xfrm>
              <a:off x="724800" y="1387515"/>
              <a:ext cx="21105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3" name="직선 연결선 222"/>
            <p:cNvCxnSpPr/>
            <p:nvPr/>
          </p:nvCxnSpPr>
          <p:spPr>
            <a:xfrm>
              <a:off x="991013" y="1387236"/>
              <a:ext cx="719982" cy="27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4" name="그룹 223"/>
          <p:cNvGrpSpPr/>
          <p:nvPr/>
        </p:nvGrpSpPr>
        <p:grpSpPr>
          <a:xfrm>
            <a:off x="687606" y="4566232"/>
            <a:ext cx="1910840" cy="804011"/>
            <a:chOff x="709403" y="596006"/>
            <a:chExt cx="1910840" cy="804011"/>
          </a:xfrm>
        </p:grpSpPr>
        <p:sp>
          <p:nvSpPr>
            <p:cNvPr id="225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 rot="16200000">
              <a:off x="456081" y="914109"/>
              <a:ext cx="739230" cy="2325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Scramble</a:t>
              </a:r>
            </a:p>
          </p:txBody>
        </p:sp>
        <p:sp>
          <p:nvSpPr>
            <p:cNvPr id="226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684861" y="1147193"/>
              <a:ext cx="9353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-CD40</a:t>
              </a:r>
            </a:p>
          </p:txBody>
        </p:sp>
        <p:sp>
          <p:nvSpPr>
            <p:cNvPr id="227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684861" y="966157"/>
              <a:ext cx="9353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-CD48</a:t>
              </a:r>
            </a:p>
          </p:txBody>
        </p:sp>
        <p:sp>
          <p:nvSpPr>
            <p:cNvPr id="228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684861" y="792431"/>
              <a:ext cx="9353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D40-V5</a:t>
              </a:r>
            </a:p>
          </p:txBody>
        </p:sp>
        <p:sp>
          <p:nvSpPr>
            <p:cNvPr id="229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684861" y="602435"/>
              <a:ext cx="9353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D48-V5</a:t>
              </a:r>
            </a:p>
          </p:txBody>
        </p:sp>
        <p:sp>
          <p:nvSpPr>
            <p:cNvPr id="230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957963" y="1131804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31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197427" y="1131804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32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453096" y="1131804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33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967536" y="951446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34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197427" y="951446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35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450086" y="951446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36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967536" y="770608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37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197427" y="770608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38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439285" y="770608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39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967536" y="596006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40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197427" y="596006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41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436798" y="596006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cxnSp>
          <p:nvCxnSpPr>
            <p:cNvPr id="242" name="직선 연결선 241"/>
            <p:cNvCxnSpPr/>
            <p:nvPr/>
          </p:nvCxnSpPr>
          <p:spPr>
            <a:xfrm>
              <a:off x="724800" y="1387515"/>
              <a:ext cx="21105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3" name="직선 연결선 242"/>
            <p:cNvCxnSpPr/>
            <p:nvPr/>
          </p:nvCxnSpPr>
          <p:spPr>
            <a:xfrm>
              <a:off x="991013" y="1387236"/>
              <a:ext cx="719982" cy="27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4" name="그룹 243"/>
          <p:cNvGrpSpPr/>
          <p:nvPr/>
        </p:nvGrpSpPr>
        <p:grpSpPr>
          <a:xfrm>
            <a:off x="3660455" y="4567763"/>
            <a:ext cx="1910840" cy="804011"/>
            <a:chOff x="709403" y="596006"/>
            <a:chExt cx="1910840" cy="804011"/>
          </a:xfrm>
        </p:grpSpPr>
        <p:sp>
          <p:nvSpPr>
            <p:cNvPr id="245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 rot="16200000">
              <a:off x="456081" y="914109"/>
              <a:ext cx="739230" cy="2325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Scramble</a:t>
              </a:r>
            </a:p>
          </p:txBody>
        </p:sp>
        <p:sp>
          <p:nvSpPr>
            <p:cNvPr id="246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684861" y="1147193"/>
              <a:ext cx="9353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-CD40</a:t>
              </a:r>
            </a:p>
          </p:txBody>
        </p:sp>
        <p:sp>
          <p:nvSpPr>
            <p:cNvPr id="247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684861" y="966157"/>
              <a:ext cx="9353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siRNA-CD48</a:t>
              </a:r>
            </a:p>
          </p:txBody>
        </p:sp>
        <p:sp>
          <p:nvSpPr>
            <p:cNvPr id="248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684861" y="792431"/>
              <a:ext cx="9353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D40-V5</a:t>
              </a:r>
            </a:p>
          </p:txBody>
        </p:sp>
        <p:sp>
          <p:nvSpPr>
            <p:cNvPr id="249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684861" y="602435"/>
              <a:ext cx="9353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D48-V5</a:t>
              </a:r>
            </a:p>
          </p:txBody>
        </p:sp>
        <p:sp>
          <p:nvSpPr>
            <p:cNvPr id="250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957963" y="1131804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51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197427" y="1131804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52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453096" y="1131804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53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967536" y="951446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54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197427" y="951446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55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450086" y="951446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56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967536" y="770608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57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197427" y="770608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58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439285" y="770608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59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967536" y="596006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60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197427" y="596006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61" name="TextBox 81">
              <a:extLst>
                <a:ext uri="{FF2B5EF4-FFF2-40B4-BE49-F238E27FC236}">
                  <a16:creationId xmlns:a16="http://schemas.microsoft.com/office/drawing/2014/main" id="{73EAA3A2-D6FC-4F7D-99AA-BB9D6FC25374}"/>
                </a:ext>
              </a:extLst>
            </p:cNvPr>
            <p:cNvSpPr txBox="1"/>
            <p:nvPr/>
          </p:nvSpPr>
          <p:spPr>
            <a:xfrm>
              <a:off x="1436798" y="596006"/>
              <a:ext cx="236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cxnSp>
          <p:nvCxnSpPr>
            <p:cNvPr id="262" name="직선 연결선 261"/>
            <p:cNvCxnSpPr/>
            <p:nvPr/>
          </p:nvCxnSpPr>
          <p:spPr>
            <a:xfrm>
              <a:off x="724800" y="1387515"/>
              <a:ext cx="21105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3" name="직선 연결선 262"/>
            <p:cNvCxnSpPr/>
            <p:nvPr/>
          </p:nvCxnSpPr>
          <p:spPr>
            <a:xfrm>
              <a:off x="991013" y="1387236"/>
              <a:ext cx="719982" cy="27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" name="그룹 3"/>
          <p:cNvGrpSpPr/>
          <p:nvPr/>
        </p:nvGrpSpPr>
        <p:grpSpPr>
          <a:xfrm>
            <a:off x="549442" y="3092652"/>
            <a:ext cx="1219537" cy="1083302"/>
            <a:chOff x="2891436" y="4597384"/>
            <a:chExt cx="1219537" cy="1083302"/>
          </a:xfrm>
        </p:grpSpPr>
        <p:pic>
          <p:nvPicPr>
            <p:cNvPr id="2" name="그림 1"/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54" t="36381" r="44702" b="29486"/>
            <a:stretch/>
          </p:blipFill>
          <p:spPr>
            <a:xfrm>
              <a:off x="2891436" y="4597501"/>
              <a:ext cx="1219537" cy="108198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" name="그림 2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66" t="36376" r="69316" b="29449"/>
            <a:stretch/>
          </p:blipFill>
          <p:spPr>
            <a:xfrm>
              <a:off x="2891913" y="4597384"/>
              <a:ext cx="174747" cy="1083302"/>
            </a:xfrm>
            <a:prstGeom prst="rect">
              <a:avLst/>
            </a:prstGeom>
          </p:spPr>
        </p:pic>
      </p:grpSp>
      <p:grpSp>
        <p:nvGrpSpPr>
          <p:cNvPr id="66" name="그룹 65"/>
          <p:cNvGrpSpPr/>
          <p:nvPr/>
        </p:nvGrpSpPr>
        <p:grpSpPr>
          <a:xfrm>
            <a:off x="3426223" y="3092652"/>
            <a:ext cx="1220856" cy="1085183"/>
            <a:chOff x="4630397" y="4466286"/>
            <a:chExt cx="1220856" cy="1085183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129" t="43658" r="36101" b="22107"/>
            <a:stretch/>
          </p:blipFill>
          <p:spPr>
            <a:xfrm>
              <a:off x="4630610" y="4466286"/>
              <a:ext cx="1220643" cy="1085183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62" name="그림 61"/>
            <p:cNvPicPr>
              <a:picLocks noChangeAspect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126" t="43688" r="60594" b="22137"/>
            <a:stretch/>
          </p:blipFill>
          <p:spPr>
            <a:xfrm>
              <a:off x="4630397" y="4467261"/>
              <a:ext cx="181667" cy="1083302"/>
            </a:xfrm>
            <a:prstGeom prst="rect">
              <a:avLst/>
            </a:prstGeom>
          </p:spPr>
        </p:pic>
      </p:grpSp>
      <p:grpSp>
        <p:nvGrpSpPr>
          <p:cNvPr id="68" name="그룹 67"/>
          <p:cNvGrpSpPr/>
          <p:nvPr/>
        </p:nvGrpSpPr>
        <p:grpSpPr>
          <a:xfrm>
            <a:off x="552758" y="6991591"/>
            <a:ext cx="1271588" cy="1505902"/>
            <a:chOff x="1865948" y="5414964"/>
            <a:chExt cx="1271588" cy="1505902"/>
          </a:xfrm>
        </p:grpSpPr>
        <p:pic>
          <p:nvPicPr>
            <p:cNvPr id="61" name="그림 60"/>
            <p:cNvPicPr>
              <a:picLocks noChangeAspect="1"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156" t="27811" r="36878" b="24683"/>
            <a:stretch/>
          </p:blipFill>
          <p:spPr>
            <a:xfrm>
              <a:off x="1866116" y="5414970"/>
              <a:ext cx="1271420" cy="150589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67" name="그림 66"/>
            <p:cNvPicPr>
              <a:picLocks noChangeAspect="1"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150" t="27813" r="62756" b="24681"/>
            <a:stretch/>
          </p:blipFill>
          <p:spPr>
            <a:xfrm>
              <a:off x="1865948" y="5414964"/>
              <a:ext cx="173746" cy="1505902"/>
            </a:xfrm>
            <a:prstGeom prst="rect">
              <a:avLst/>
            </a:prstGeom>
          </p:spPr>
        </p:pic>
      </p:grpSp>
      <p:sp>
        <p:nvSpPr>
          <p:cNvPr id="163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266354" y="6540771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4" name="직선 연결선 163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510376" y="6663581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4" name="그룹 73"/>
          <p:cNvGrpSpPr/>
          <p:nvPr/>
        </p:nvGrpSpPr>
        <p:grpSpPr>
          <a:xfrm>
            <a:off x="3461084" y="6994575"/>
            <a:ext cx="1267675" cy="1507958"/>
            <a:chOff x="3461084" y="6994575"/>
            <a:chExt cx="1267675" cy="1507958"/>
          </a:xfrm>
        </p:grpSpPr>
        <p:pic>
          <p:nvPicPr>
            <p:cNvPr id="72" name="그림 71"/>
            <p:cNvPicPr>
              <a:picLocks noChangeAspect="1"/>
            </p:cNvPicPr>
            <p:nvPr/>
          </p:nvPicPr>
          <p:blipFill rotWithShape="1"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232" t="30045" r="35889" b="22391"/>
            <a:stretch/>
          </p:blipFill>
          <p:spPr>
            <a:xfrm>
              <a:off x="3461084" y="6994575"/>
              <a:ext cx="1267675" cy="150774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73" name="그림 72"/>
            <p:cNvPicPr>
              <a:picLocks noChangeAspect="1"/>
            </p:cNvPicPr>
            <p:nvPr/>
          </p:nvPicPr>
          <p:blipFill rotWithShape="1"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287" t="30043" r="61313" b="22387"/>
            <a:stretch/>
          </p:blipFill>
          <p:spPr>
            <a:xfrm>
              <a:off x="3463349" y="6994576"/>
              <a:ext cx="186632" cy="1507957"/>
            </a:xfrm>
            <a:prstGeom prst="rect">
              <a:avLst/>
            </a:prstGeom>
          </p:spPr>
        </p:pic>
      </p:grpSp>
      <p:sp>
        <p:nvSpPr>
          <p:cNvPr id="194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275095" y="3115974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5" name="직선 연결선 194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513072" y="3240163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7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3144799" y="3114262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8" name="직선 연결선 197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3385376" y="3237981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3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272046" y="7529308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4" name="직선 연결선 293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516068" y="7657144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5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272046" y="7810779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6" name="직선 연결선 295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516068" y="7936533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7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272046" y="7263542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8" name="직선 연결선 297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516068" y="7387446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9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272046" y="8102248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0" name="직선 연결선 299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516068" y="8225058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1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3170386" y="6104984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2" name="직선 연결선 301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3414408" y="6232820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3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3170386" y="6376407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4" name="직선 연결선 303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3414408" y="6502161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5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3170386" y="5839218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6" name="직선 연결선 305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3414408" y="5963122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7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3170386" y="6667876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8" name="직선 연결선 307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3414408" y="6790686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7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3170386" y="7679520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8" name="직선 연결선 317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3414408" y="7807356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9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3170386" y="7960991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0" name="직선 연결선 319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3414408" y="8086745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1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3170386" y="7413754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2" name="직선 연결선 321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3414408" y="7537658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3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3170386" y="8252460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4" name="직선 연결선 323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3414408" y="8375270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5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268164" y="9171292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6" name="직선 연결선 325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512186" y="9299128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7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268164" y="9452763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8" name="직선 연결선 327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512186" y="9578517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9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268164" y="8905526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0" name="직선 연결선 329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512186" y="9029430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1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268164" y="9744232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2" name="직선 연결선 331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512186" y="9867042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3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3170737" y="9148702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4" name="직선 연결선 333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3414759" y="9276538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5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3170737" y="9430173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6" name="직선 연결선 335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3414759" y="9555927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7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3170737" y="8882936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8" name="직선 연결선 337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3414759" y="9006840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9" name="TextBox 88">
            <a:extLst>
              <a:ext uri="{FF2B5EF4-FFF2-40B4-BE49-F238E27FC236}">
                <a16:creationId xmlns:a16="http://schemas.microsoft.com/office/drawing/2014/main" id="{300C2D80-8F1F-4D3C-BF7D-F8AA0B911858}"/>
              </a:ext>
            </a:extLst>
          </p:cNvPr>
          <p:cNvSpPr txBox="1"/>
          <p:nvPr/>
        </p:nvSpPr>
        <p:spPr>
          <a:xfrm>
            <a:off x="3170737" y="9721642"/>
            <a:ext cx="3418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0" name="직선 연결선 339">
            <a:extLst>
              <a:ext uri="{FF2B5EF4-FFF2-40B4-BE49-F238E27FC236}">
                <a16:creationId xmlns:a16="http://schemas.microsoft.com/office/drawing/2014/main" id="{1B3DD367-1F22-43C2-AA2C-66F916BB6AE8}"/>
              </a:ext>
            </a:extLst>
          </p:cNvPr>
          <p:cNvCxnSpPr>
            <a:cxnSpLocks/>
          </p:cNvCxnSpPr>
          <p:nvPr/>
        </p:nvCxnSpPr>
        <p:spPr>
          <a:xfrm>
            <a:off x="3414759" y="9844452"/>
            <a:ext cx="2663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1" name="TextBox 340">
            <a:extLst>
              <a:ext uri="{FF2B5EF4-FFF2-40B4-BE49-F238E27FC236}">
                <a16:creationId xmlns:a16="http://schemas.microsoft.com/office/drawing/2014/main" id="{462A84C4-FDCD-4E72-A58C-C340C8AFF135}"/>
              </a:ext>
            </a:extLst>
          </p:cNvPr>
          <p:cNvSpPr txBox="1"/>
          <p:nvPr/>
        </p:nvSpPr>
        <p:spPr>
          <a:xfrm>
            <a:off x="3240450" y="5961397"/>
            <a:ext cx="3418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2" name="TextBox 341">
            <a:extLst>
              <a:ext uri="{FF2B5EF4-FFF2-40B4-BE49-F238E27FC236}">
                <a16:creationId xmlns:a16="http://schemas.microsoft.com/office/drawing/2014/main" id="{462A84C4-FDCD-4E72-A58C-C340C8AFF135}"/>
              </a:ext>
            </a:extLst>
          </p:cNvPr>
          <p:cNvSpPr txBox="1"/>
          <p:nvPr/>
        </p:nvSpPr>
        <p:spPr>
          <a:xfrm>
            <a:off x="337393" y="7936233"/>
            <a:ext cx="3418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3" name="TextBox 342">
            <a:extLst>
              <a:ext uri="{FF2B5EF4-FFF2-40B4-BE49-F238E27FC236}">
                <a16:creationId xmlns:a16="http://schemas.microsoft.com/office/drawing/2014/main" id="{462A84C4-FDCD-4E72-A58C-C340C8AFF135}"/>
              </a:ext>
            </a:extLst>
          </p:cNvPr>
          <p:cNvSpPr txBox="1"/>
          <p:nvPr/>
        </p:nvSpPr>
        <p:spPr>
          <a:xfrm>
            <a:off x="3240450" y="7551421"/>
            <a:ext cx="3418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4" name="직선 화살표 연결선 83"/>
          <p:cNvCxnSpPr/>
          <p:nvPr/>
        </p:nvCxnSpPr>
        <p:spPr>
          <a:xfrm flipH="1">
            <a:off x="1824347" y="2386820"/>
            <a:ext cx="145504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4" name="직선 화살표 연결선 343"/>
          <p:cNvCxnSpPr/>
          <p:nvPr/>
        </p:nvCxnSpPr>
        <p:spPr>
          <a:xfrm flipH="1">
            <a:off x="4712604" y="2377767"/>
            <a:ext cx="136634" cy="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5" name="직선 화살표 연결선 344"/>
          <p:cNvCxnSpPr/>
          <p:nvPr/>
        </p:nvCxnSpPr>
        <p:spPr>
          <a:xfrm flipH="1">
            <a:off x="1827437" y="2471125"/>
            <a:ext cx="142414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4" name="TextBox 263">
            <a:extLst>
              <a:ext uri="{FF2B5EF4-FFF2-40B4-BE49-F238E27FC236}">
                <a16:creationId xmlns:a16="http://schemas.microsoft.com/office/drawing/2014/main" id="{462A84C4-FDCD-4E72-A58C-C340C8AFF135}"/>
              </a:ext>
            </a:extLst>
          </p:cNvPr>
          <p:cNvSpPr txBox="1"/>
          <p:nvPr/>
        </p:nvSpPr>
        <p:spPr>
          <a:xfrm>
            <a:off x="341738" y="6361275"/>
            <a:ext cx="3418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436856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9599DD4-0ECF-70D4-B83F-467D8B01779E}"/>
              </a:ext>
            </a:extLst>
          </p:cNvPr>
          <p:cNvSpPr txBox="1"/>
          <p:nvPr/>
        </p:nvSpPr>
        <p:spPr>
          <a:xfrm>
            <a:off x="243347" y="707819"/>
            <a:ext cx="724883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latinLnBrk="1">
              <a:spcAft>
                <a:spcPts val="800"/>
              </a:spcAft>
            </a:pPr>
            <a:r>
              <a:rPr lang="en-US" altLang="ko-KR" sz="1200" b="1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mentary FIGURE</a:t>
            </a:r>
            <a:r>
              <a:rPr lang="en-US" altLang="ko-KR" sz="12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200" b="1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5 </a:t>
            </a:r>
            <a:r>
              <a:rPr lang="en-US" altLang="ko-KR" sz="12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Original western blot data for (A) Figure S4A and (B) S4B. Asterisk (*) indicates main signal band. The black arrow indicates endogenous </a:t>
            </a:r>
            <a:r>
              <a:rPr lang="en-US" altLang="ko-KR" sz="1200" kern="100" dirty="0" err="1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protei</a:t>
            </a:r>
            <a:r>
              <a:rPr lang="en-US" altLang="ko-KR" sz="12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,</a:t>
            </a:r>
            <a:r>
              <a:rPr lang="en-US" altLang="ko-KR" sz="12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and the blue arrow indicates the V5 tagged protein.</a:t>
            </a:r>
            <a:endParaRPr lang="ko-KR" altLang="ko-KR" sz="10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184552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561</TotalTime>
  <Words>205</Words>
  <Application>Microsoft Office PowerPoint</Application>
  <PresentationFormat>사용자 지정</PresentationFormat>
  <Paragraphs>125</Paragraphs>
  <Slides>2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BRI</dc:creator>
  <cp:lastModifiedBy>JooJaeyeol</cp:lastModifiedBy>
  <cp:revision>828</cp:revision>
  <cp:lastPrinted>2020-05-22T07:46:34Z</cp:lastPrinted>
  <dcterms:created xsi:type="dcterms:W3CDTF">2017-05-04T04:46:32Z</dcterms:created>
  <dcterms:modified xsi:type="dcterms:W3CDTF">2022-11-11T22:51:15Z</dcterms:modified>
</cp:coreProperties>
</file>